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3"/>
  </p:notesMasterIdLst>
  <p:sldIdLst>
    <p:sldId id="256" r:id="rId2"/>
    <p:sldId id="270" r:id="rId3"/>
    <p:sldId id="257" r:id="rId4"/>
    <p:sldId id="273" r:id="rId5"/>
    <p:sldId id="260" r:id="rId6"/>
    <p:sldId id="274" r:id="rId7"/>
    <p:sldId id="275" r:id="rId8"/>
    <p:sldId id="259" r:id="rId9"/>
    <p:sldId id="261" r:id="rId10"/>
    <p:sldId id="262" r:id="rId11"/>
    <p:sldId id="264" r:id="rId12"/>
    <p:sldId id="277" r:id="rId13"/>
    <p:sldId id="265" r:id="rId14"/>
    <p:sldId id="266" r:id="rId15"/>
    <p:sldId id="268" r:id="rId16"/>
    <p:sldId id="267" r:id="rId17"/>
    <p:sldId id="276" r:id="rId18"/>
    <p:sldId id="272" r:id="rId19"/>
    <p:sldId id="278" r:id="rId20"/>
    <p:sldId id="280" r:id="rId21"/>
    <p:sldId id="281" r:id="rId2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8" d="100"/>
          <a:sy n="68" d="100"/>
        </p:scale>
        <p:origin x="79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A326004-DA4F-449E-980E-4355096F29A5}" type="datetimeFigureOut">
              <a:rPr lang="en-IN" smtClean="0"/>
              <a:t>09-08-2022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EB6A9FD-DACA-489C-8D1D-DEAD9868903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214600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EB6A9FD-DACA-489C-8D1D-DEAD98689036}" type="slidenum">
              <a:rPr lang="en-IN" smtClean="0"/>
              <a:t>2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363385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EB6A9FD-DACA-489C-8D1D-DEAD98689036}" type="slidenum">
              <a:rPr lang="en-IN" smtClean="0"/>
              <a:t>5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1268377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EB6A9FD-DACA-489C-8D1D-DEAD98689036}" type="slidenum">
              <a:rPr lang="en-IN" smtClean="0"/>
              <a:t>16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141587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1CB7EC-91FB-4803-984D-72A6C3CC48A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C4412D8-3D9B-43DF-8882-23E5D07FE55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71B2CAA-B8F8-46B3-B293-7D25427926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22F2D3-5E84-48E4-9964-A72614D7E609}" type="datetime1">
              <a:rPr lang="en-IN" smtClean="0"/>
              <a:t>09-08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AB199F-8B9C-49E9-9468-6226E8B0B8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pollo Multispeciality Hospital Kolkata, India</a:t>
            </a:r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AE9B17-9615-4D0F-8403-CED825874B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72C7A-1B5E-454A-A45A-13AF0C11F55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438968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DAD78A-B791-47D7-95E8-416FAC749C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3510D82-1D3E-4358-B36E-16AEC72EFD1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BF1A01-6F41-48FD-8FEA-6956A2B305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5C87B-EA8D-41A3-BC0F-BBEDC2FCDDA5}" type="datetime1">
              <a:rPr lang="en-IN" smtClean="0"/>
              <a:t>09-08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F067786-5B11-4A4B-A538-2C3241635D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pollo Multispeciality Hospital Kolkata, India</a:t>
            </a:r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3CA445-F36D-4E9A-B3FA-E79B434797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72C7A-1B5E-454A-A45A-13AF0C11F55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723741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5E22ED6-1A5B-4AE6-A14F-71F301F97DC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C210E4A-4777-4441-931C-74C5219657A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9A5F37-8C37-4316-A1FC-D3F46E4A64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E4CE8-C1AE-4819-BE28-810B749C53A4}" type="datetime1">
              <a:rPr lang="en-IN" smtClean="0"/>
              <a:t>09-08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EC5383-735E-4915-A824-337B3E3BAB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pollo Multispeciality Hospital Kolkata, India</a:t>
            </a:r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4EAAFB-4854-49AC-86D6-4C9C74D002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72C7A-1B5E-454A-A45A-13AF0C11F55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869858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1DB2A9-E793-44AE-A33C-B13665083E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3BAC60-57FC-4A31-9591-2CAC1948F06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6E98E0-489C-4EB9-8F3E-C523D34FBD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D5B577-3A28-4728-89C1-C2FF738F7023}" type="datetime1">
              <a:rPr lang="en-IN" smtClean="0"/>
              <a:t>09-08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30CD95-C0BF-47D0-9436-981BC7E47A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pollo Multispeciality Hospital Kolkata, India</a:t>
            </a:r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4D6631-0BDB-4AB6-957D-A6BEEF16A8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72C7A-1B5E-454A-A45A-13AF0C11F55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364753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779055-B162-457F-98ED-0857A3B67E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1E2E97C-243E-4280-B7B0-128542A536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E81168-B630-4027-8082-5620E1D6D5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CB2CA-AAA7-48C9-AE8C-3552169FA6C5}" type="datetime1">
              <a:rPr lang="en-IN" smtClean="0"/>
              <a:t>09-08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DA2C0D-8FF2-44F4-B73B-ACFC051067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pollo Multispeciality Hospital Kolkata, India</a:t>
            </a:r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265879-9DEE-4934-80A3-57BD030856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72C7A-1B5E-454A-A45A-13AF0C11F55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241902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1CEF8A-FB3F-48E8-A81A-52361F9062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30D6DFC-A621-405C-A4CB-0B9C559194A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AB7436B-8355-496A-9C3A-5BDA97DAE25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B06E8DA-24E9-4331-8F05-01C07A13B7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782A2-F4CB-4305-891A-E4740B285609}" type="datetime1">
              <a:rPr lang="en-IN" smtClean="0"/>
              <a:t>09-08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65F90D2-858C-4267-B83C-5A352493D4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pollo Multispeciality Hospital Kolkata, India</a:t>
            </a:r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65C7C67-0BAA-46B8-BD47-18227AB9FB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72C7A-1B5E-454A-A45A-13AF0C11F55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553395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7ED725-C0B2-4A69-BEAD-41BF4BB1D1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674DDEF-C74F-4436-8BED-197C17BEEE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D77991B-3262-4FC9-8C34-6B83A7A035F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BC34400-29C1-46E3-AC54-FD4F89A3F44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7B25F9D-34C2-4892-82A5-926348ED779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86C333A-449A-42C1-B0AA-5C68C1AE83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EBE24-6E22-4A6B-9028-C085E024DD83}" type="datetime1">
              <a:rPr lang="en-IN" smtClean="0"/>
              <a:t>09-08-2022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4B06AD0-4BF7-4173-BF6D-9D312FC372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pollo Multispeciality Hospital Kolkata, India</a:t>
            </a:r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52D6776-E46E-488F-A7F0-467D6AD565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72C7A-1B5E-454A-A45A-13AF0C11F55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242014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C7DF8E-9893-42CF-A8BE-74EDD5105A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DC7F7F4-DA67-4066-9D7C-E03735153D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78001-42E3-4305-AD6A-5F9D81E84E20}" type="datetime1">
              <a:rPr lang="en-IN" smtClean="0"/>
              <a:t>09-08-2022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BF91DF3-0114-4B9C-979D-6C48E86D84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pollo Multispeciality Hospital Kolkata, India</a:t>
            </a:r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3E9A252-C0ED-4142-B07E-7EF6FB7800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72C7A-1B5E-454A-A45A-13AF0C11F55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974820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6F71B36-6FCE-4D98-999B-0158E570E4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E59FAD-AA1E-4B4F-A481-DFD8DD330309}" type="datetime1">
              <a:rPr lang="en-IN" smtClean="0"/>
              <a:t>09-08-2022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39CD757-6C2B-434D-BFD1-90F705A591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pollo Multispeciality Hospital Kolkata, India</a:t>
            </a:r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D7C07D2-79F8-4376-8E32-7B8ECCAC35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72C7A-1B5E-454A-A45A-13AF0C11F55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668730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7AB3CC-8B33-411D-83D9-B301C6A46F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4915396-B1AC-4C2A-AE8F-4E49EEFCFFE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E1713B9-6898-465C-A136-A55F7091BB8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B27C485-29A1-4346-9308-EC24338285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425CB-1F2A-4C7A-B854-CEFBE111FFF2}" type="datetime1">
              <a:rPr lang="en-IN" smtClean="0"/>
              <a:t>09-08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52F4704-E864-466B-A9E1-E07285B88B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pollo Multispeciality Hospital Kolkata, India</a:t>
            </a:r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9FB281A-26CA-46DC-A431-E2D48AB4CB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72C7A-1B5E-454A-A45A-13AF0C11F55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799196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785615-9A62-4966-9B35-7B9E54CA72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03A97E7-F20B-4DB6-BA6D-7A1B98C54C2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976B361-9BE5-4FA2-ADB5-FDF1B28F3C5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ED89657-F80E-4807-A919-B30D1F5093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945F2-BC29-4608-84AA-191D47C08C28}" type="datetime1">
              <a:rPr lang="en-IN" smtClean="0"/>
              <a:t>09-08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BEF6B2A-BC73-4AD3-8F26-A539174928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pollo Multispeciality Hospital Kolkata, India</a:t>
            </a:r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578219B-6329-4DC5-A0F9-F1ECF95718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72C7A-1B5E-454A-A45A-13AF0C11F55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95123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A3C4A08-0693-46E2-BD44-7C5936A1BD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30928FE-A5B3-44F5-A74D-9E5CB3A63C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A54863-75FA-4F96-A8E2-BEC6AB63ABC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3EB5B6-FAF8-4CE0-8F96-836F760A4DC8}" type="datetime1">
              <a:rPr lang="en-IN" smtClean="0"/>
              <a:t>09-08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E21F6F-1018-442F-9F3D-92F18C01ACD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it-IT"/>
              <a:t>Apollo Multispeciality Hospital Kolkata, India</a:t>
            </a:r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62CC49-326B-4D3B-8CC2-42E65A24A67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372C7A-1B5E-454A-A45A-13AF0C11F55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710305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9AEE6B-E6D2-4235-8731-722C4338004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275359" y="2736806"/>
            <a:ext cx="9144000" cy="2387600"/>
          </a:xfrm>
        </p:spPr>
        <p:txBody>
          <a:bodyPr>
            <a:normAutofit/>
          </a:bodyPr>
          <a:lstStyle/>
          <a:p>
            <a:r>
              <a:rPr lang="en-IN" dirty="0"/>
              <a:t>TMI/TMLI Patient Simulation and planning Detail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56D5BA0-F219-ACFE-A173-7740A059D4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72C7A-1B5E-454A-A45A-13AF0C11F554}" type="slidenum">
              <a:rPr lang="en-IN" smtClean="0">
                <a:solidFill>
                  <a:srgbClr val="002060"/>
                </a:solidFill>
              </a:rPr>
              <a:t>1</a:t>
            </a:fld>
            <a:endParaRPr lang="en-IN" dirty="0">
              <a:solidFill>
                <a:srgbClr val="002060"/>
              </a:solidFill>
            </a:endParaRPr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B3B64B-0599-75E6-93A0-82F4115397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 dirty="0">
                <a:solidFill>
                  <a:srgbClr val="002060"/>
                </a:solidFill>
              </a:rPr>
              <a:t>Apollo Multispeciality Hospital Kolkata, India</a:t>
            </a:r>
            <a:endParaRPr lang="en-IN" dirty="0">
              <a:solidFill>
                <a:srgbClr val="002060"/>
              </a:solidFill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6AE0AA9-AF2D-AD15-DE84-80F26A1648C2}"/>
              </a:ext>
            </a:extLst>
          </p:cNvPr>
          <p:cNvSpPr txBox="1"/>
          <p:nvPr/>
        </p:nvSpPr>
        <p:spPr>
          <a:xfrm>
            <a:off x="843840" y="1273200"/>
            <a:ext cx="9444333" cy="22475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IN" sz="2400" b="1" dirty="0">
                <a:solidFill>
                  <a:srgbClr val="0000CC"/>
                </a:solidFill>
              </a:rPr>
              <a:t>Additional file: </a:t>
            </a:r>
            <a:r>
              <a:rPr lang="en-IN" sz="2400" b="1" dirty="0">
                <a:solidFill>
                  <a:srgbClr val="0000CC"/>
                </a:solidFill>
                <a:effectLst/>
                <a:ea typeface="Calibri" panose="020F0502020204030204" pitchFamily="34" charset="0"/>
                <a:cs typeface="Calibri" panose="020F0502020204030204" pitchFamily="34" charset="0"/>
              </a:rPr>
              <a:t>Preclinical validation and treatment  of Volumetric Modulated Arc Therapy Based Total Bone Marrow Irradiation in Halcyon™ Ring Gantry Linear Accelerator.</a:t>
            </a:r>
            <a:endParaRPr lang="en-IN" sz="2400" b="1" dirty="0">
              <a:solidFill>
                <a:srgbClr val="0000CC"/>
              </a:solidFill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IN" sz="2400" dirty="0">
                <a:effectLst/>
                <a:ea typeface="Calibri" panose="020F0502020204030204" pitchFamily="34" charset="0"/>
                <a:cs typeface="Calibri" panose="020F0502020204030204" pitchFamily="34" charset="0"/>
              </a:rPr>
              <a:t> </a:t>
            </a:r>
            <a:endParaRPr lang="en-IN" sz="24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IN" sz="2400" dirty="0"/>
          </a:p>
        </p:txBody>
      </p:sp>
    </p:spTree>
    <p:extLst>
      <p:ext uri="{BB962C8B-B14F-4D97-AF65-F5344CB8AC3E}">
        <p14:creationId xmlns:p14="http://schemas.microsoft.com/office/powerpoint/2010/main" val="260855185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B17829-FC6A-4D23-BF2A-3A56B87A12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2443944"/>
            <a:ext cx="3108960" cy="1970112"/>
          </a:xfrm>
        </p:spPr>
        <p:txBody>
          <a:bodyPr>
            <a:normAutofit fontScale="90000"/>
          </a:bodyPr>
          <a:lstStyle/>
          <a:p>
            <a:r>
              <a:rPr lang="en-IN" b="1" u="sng" dirty="0"/>
              <a:t>HFS</a:t>
            </a:r>
            <a:br>
              <a:rPr lang="en-IN" dirty="0"/>
            </a:br>
            <a:br>
              <a:rPr lang="en-IN" dirty="0"/>
            </a:br>
            <a:r>
              <a:rPr lang="en-IN" dirty="0"/>
              <a:t>Optimization Parameters Set -3 of 4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D8F1C9D-CEF9-20DD-E434-AD3D671AA9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9201443" y="6492875"/>
            <a:ext cx="2743200" cy="365125"/>
          </a:xfrm>
        </p:spPr>
        <p:txBody>
          <a:bodyPr/>
          <a:lstStyle/>
          <a:p>
            <a:fld id="{C6372C7A-1B5E-454A-A45A-13AF0C11F554}" type="slidenum">
              <a:rPr lang="en-IN" smtClean="0">
                <a:solidFill>
                  <a:srgbClr val="002060"/>
                </a:solidFill>
              </a:rPr>
              <a:t>10</a:t>
            </a:fld>
            <a:endParaRPr lang="en-IN" dirty="0">
              <a:solidFill>
                <a:srgbClr val="002060"/>
              </a:solidFill>
            </a:endParaRPr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4513F38-D9FD-49AA-2ADB-5B34EA4863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457693"/>
            <a:ext cx="4114800" cy="365125"/>
          </a:xfrm>
        </p:spPr>
        <p:txBody>
          <a:bodyPr/>
          <a:lstStyle/>
          <a:p>
            <a:r>
              <a:rPr lang="it-IT" dirty="0">
                <a:solidFill>
                  <a:srgbClr val="002060"/>
                </a:solidFill>
              </a:rPr>
              <a:t>Apollo Multispeciality Hospital Kolkata, India</a:t>
            </a:r>
            <a:endParaRPr lang="en-IN" dirty="0">
              <a:solidFill>
                <a:srgbClr val="002060"/>
              </a:solidFill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/>
          <a:srcRect t="2688" b="4088"/>
          <a:stretch/>
        </p:blipFill>
        <p:spPr>
          <a:xfrm>
            <a:off x="3248296" y="148046"/>
            <a:ext cx="8943703" cy="63096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9963744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B17829-FC6A-4D23-BF2A-3A56B87A12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2236129"/>
            <a:ext cx="3108960" cy="1970112"/>
          </a:xfrm>
        </p:spPr>
        <p:txBody>
          <a:bodyPr>
            <a:normAutofit fontScale="90000"/>
          </a:bodyPr>
          <a:lstStyle/>
          <a:p>
            <a:r>
              <a:rPr lang="en-IN" b="1" u="sng" dirty="0"/>
              <a:t>HFS </a:t>
            </a:r>
            <a:br>
              <a:rPr lang="en-IN" dirty="0"/>
            </a:br>
            <a:br>
              <a:rPr lang="en-IN" dirty="0"/>
            </a:br>
            <a:r>
              <a:rPr lang="en-IN" dirty="0"/>
              <a:t>Optimization Parameters Set -4 of 4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E0A19F0-C77E-FC59-328F-8332DE841C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9299917" y="6453382"/>
            <a:ext cx="2743200" cy="365125"/>
          </a:xfrm>
        </p:spPr>
        <p:txBody>
          <a:bodyPr/>
          <a:lstStyle/>
          <a:p>
            <a:fld id="{C6372C7A-1B5E-454A-A45A-13AF0C11F554}" type="slidenum">
              <a:rPr lang="en-IN" smtClean="0">
                <a:solidFill>
                  <a:srgbClr val="002060"/>
                </a:solidFill>
              </a:rPr>
              <a:t>11</a:t>
            </a:fld>
            <a:endParaRPr lang="en-IN" dirty="0">
              <a:solidFill>
                <a:srgbClr val="002060"/>
              </a:solidFill>
            </a:endParaRPr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5D7BBA5-CE3F-915A-E9EF-2F171CF143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460099"/>
            <a:ext cx="4114800" cy="365125"/>
          </a:xfrm>
        </p:spPr>
        <p:txBody>
          <a:bodyPr/>
          <a:lstStyle/>
          <a:p>
            <a:r>
              <a:rPr lang="it-IT">
                <a:solidFill>
                  <a:srgbClr val="002060"/>
                </a:solidFill>
              </a:rPr>
              <a:t>Apollo Multispeciality Hospital Kolkata, India</a:t>
            </a:r>
            <a:endParaRPr lang="en-IN">
              <a:solidFill>
                <a:srgbClr val="002060"/>
              </a:solidFill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/>
          <a:srcRect t="2218" b="4227"/>
          <a:stretch/>
        </p:blipFill>
        <p:spPr>
          <a:xfrm>
            <a:off x="3004457" y="148046"/>
            <a:ext cx="9038659" cy="62353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4382960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4A83C7-5E16-4532-9DB3-D6B3757CDF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2062" y="335009"/>
            <a:ext cx="12027876" cy="1325563"/>
          </a:xfrm>
        </p:spPr>
        <p:txBody>
          <a:bodyPr>
            <a:normAutofit/>
          </a:bodyPr>
          <a:lstStyle/>
          <a:p>
            <a:r>
              <a:rPr lang="en-IN" sz="3200" dirty="0"/>
              <a:t>Isocentre placement and Dose Distribution (coronal)-HFS  </a:t>
            </a:r>
            <a:r>
              <a:rPr lang="en-IN" sz="3200" b="1" dirty="0">
                <a:solidFill>
                  <a:srgbClr val="00B0F0"/>
                </a:solidFill>
              </a:rPr>
              <a:t>Element-2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6D39B7E-5AC3-4015-8C98-577EB61A6BA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0000" t="15732" r="34322" b="20265"/>
          <a:stretch/>
        </p:blipFill>
        <p:spPr>
          <a:xfrm rot="16200000">
            <a:off x="2902084" y="-759938"/>
            <a:ext cx="4697367" cy="9868487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6325787C-A9AA-4572-895B-FBD5956108C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5601" t="14760" r="77535" b="54944"/>
          <a:stretch/>
        </p:blipFill>
        <p:spPr>
          <a:xfrm>
            <a:off x="10185010" y="1825624"/>
            <a:ext cx="1842867" cy="4697367"/>
          </a:xfrm>
          <a:prstGeom prst="rect">
            <a:avLst/>
          </a:prstGeom>
        </p:spPr>
      </p:pic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1DF2E6A-2C2E-85D1-E1EB-64C8F14028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9132276" y="6492658"/>
            <a:ext cx="2743200" cy="365125"/>
          </a:xfrm>
        </p:spPr>
        <p:txBody>
          <a:bodyPr/>
          <a:lstStyle/>
          <a:p>
            <a:fld id="{C6372C7A-1B5E-454A-A45A-13AF0C11F554}" type="slidenum">
              <a:rPr lang="en-IN" smtClean="0">
                <a:solidFill>
                  <a:srgbClr val="002060"/>
                </a:solidFill>
              </a:rPr>
              <a:t>12</a:t>
            </a:fld>
            <a:endParaRPr lang="en-IN" dirty="0">
              <a:solidFill>
                <a:srgbClr val="002060"/>
              </a:solidFill>
            </a:endParaRPr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D092665-3C92-165F-53DA-1DF56F463A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513443"/>
            <a:ext cx="4114800" cy="365125"/>
          </a:xfrm>
        </p:spPr>
        <p:txBody>
          <a:bodyPr/>
          <a:lstStyle/>
          <a:p>
            <a:r>
              <a:rPr lang="it-IT" dirty="0">
                <a:solidFill>
                  <a:srgbClr val="002060"/>
                </a:solidFill>
              </a:rPr>
              <a:t>Apollo Multispeciality Hospital Kolkata, India</a:t>
            </a:r>
            <a:endParaRPr lang="en-IN" dirty="0">
              <a:solidFill>
                <a:srgbClr val="00206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6778675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4A83C7-5E16-4532-9DB3-D6B3757CDF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8475" y="365125"/>
            <a:ext cx="11929402" cy="1325563"/>
          </a:xfrm>
        </p:spPr>
        <p:txBody>
          <a:bodyPr>
            <a:normAutofit/>
          </a:bodyPr>
          <a:lstStyle/>
          <a:p>
            <a:r>
              <a:rPr lang="en-IN" sz="4000" dirty="0"/>
              <a:t>Isocentre placement and Dose Distribution (Sagittal)-HFS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3896207A-0506-4B05-AF0C-03BE4CD4A3F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0001" t="15289" r="31834" b="19942"/>
          <a:stretch/>
        </p:blipFill>
        <p:spPr>
          <a:xfrm rot="16200000">
            <a:off x="3047268" y="-926223"/>
            <a:ext cx="4695386" cy="1014280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E075A562-A183-4877-9A12-EBFBF6BC0AF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5602" t="15042" r="74694" b="53261"/>
          <a:stretch/>
        </p:blipFill>
        <p:spPr>
          <a:xfrm>
            <a:off x="10466366" y="1797488"/>
            <a:ext cx="1725634" cy="4695387"/>
          </a:xfrm>
          <a:prstGeom prst="rect">
            <a:avLst/>
          </a:prstGeom>
        </p:spPr>
      </p:pic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B71F28C-29AE-4B39-24D2-301146DDCF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9284677" y="6492875"/>
            <a:ext cx="2743200" cy="365125"/>
          </a:xfrm>
        </p:spPr>
        <p:txBody>
          <a:bodyPr/>
          <a:lstStyle/>
          <a:p>
            <a:fld id="{C6372C7A-1B5E-454A-A45A-13AF0C11F554}" type="slidenum">
              <a:rPr lang="en-IN" smtClean="0">
                <a:solidFill>
                  <a:srgbClr val="002060"/>
                </a:solidFill>
              </a:rPr>
              <a:t>13</a:t>
            </a:fld>
            <a:endParaRPr lang="en-IN" dirty="0">
              <a:solidFill>
                <a:srgbClr val="002060"/>
              </a:solidFill>
            </a:endParaRPr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1545F3-9008-3C61-2C53-2F47C9026A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417112"/>
            <a:ext cx="4114800" cy="365125"/>
          </a:xfrm>
        </p:spPr>
        <p:txBody>
          <a:bodyPr/>
          <a:lstStyle/>
          <a:p>
            <a:r>
              <a:rPr lang="it-IT" dirty="0">
                <a:solidFill>
                  <a:srgbClr val="002060"/>
                </a:solidFill>
              </a:rPr>
              <a:t>Apollo Multispeciality Hospital Kolkata, India</a:t>
            </a:r>
            <a:endParaRPr lang="en-IN" dirty="0">
              <a:solidFill>
                <a:srgbClr val="00206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40637103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1791DB-F861-456F-B77A-499F5D7945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81206"/>
            <a:ext cx="10515600" cy="1325563"/>
          </a:xfrm>
        </p:spPr>
        <p:txBody>
          <a:bodyPr/>
          <a:lstStyle/>
          <a:p>
            <a:r>
              <a:rPr lang="en-IN" sz="4400" dirty="0"/>
              <a:t>Arcs and Dose Distribution (Axial)- HFS CT</a:t>
            </a:r>
            <a:endParaRPr lang="en-IN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320CEF3-989C-40AB-8B53-C76A5D74B00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8797" t="18126" r="21439" b="20861"/>
          <a:stretch/>
        </p:blipFill>
        <p:spPr>
          <a:xfrm>
            <a:off x="1744394" y="1406769"/>
            <a:ext cx="7573108" cy="4931362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604EB5D3-B64D-48E8-B53C-4770DECDCC9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5602" t="13918" r="77771" b="54944"/>
          <a:stretch/>
        </p:blipFill>
        <p:spPr>
          <a:xfrm>
            <a:off x="9353258" y="1406769"/>
            <a:ext cx="1740875" cy="4931362"/>
          </a:xfrm>
          <a:prstGeom prst="rect">
            <a:avLst/>
          </a:prstGeom>
        </p:spPr>
      </p:pic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EBE0775-4D47-1025-55AB-3647621872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72C7A-1B5E-454A-A45A-13AF0C11F554}" type="slidenum">
              <a:rPr lang="en-IN" smtClean="0">
                <a:solidFill>
                  <a:srgbClr val="002060"/>
                </a:solidFill>
              </a:rPr>
              <a:t>14</a:t>
            </a:fld>
            <a:endParaRPr lang="en-IN" dirty="0">
              <a:solidFill>
                <a:srgbClr val="002060"/>
              </a:solidFill>
            </a:endParaRPr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EFEFF16-D422-FD78-13BD-5C75794983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 dirty="0">
                <a:solidFill>
                  <a:srgbClr val="002060"/>
                </a:solidFill>
              </a:rPr>
              <a:t>Apollo Multispeciality Hospital Kolkata, India</a:t>
            </a:r>
            <a:endParaRPr lang="en-IN" dirty="0">
              <a:solidFill>
                <a:srgbClr val="00206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8350484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B6AB21-5A7D-49FD-AC3A-FB1F6D4D60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336430" y="280720"/>
            <a:ext cx="9544757" cy="1140118"/>
          </a:xfrm>
        </p:spPr>
        <p:txBody>
          <a:bodyPr>
            <a:normAutofit fontScale="90000"/>
          </a:bodyPr>
          <a:lstStyle/>
          <a:p>
            <a:r>
              <a:rPr lang="en-IN" b="1" u="sng" dirty="0"/>
              <a:t>FFS Plan : </a:t>
            </a:r>
            <a:br>
              <a:rPr lang="en-IN" b="1" u="sng" dirty="0"/>
            </a:br>
            <a:r>
              <a:rPr lang="en-IN" dirty="0"/>
              <a:t>Beam Arrangement and MU</a:t>
            </a:r>
            <a:br>
              <a:rPr lang="en-IN" dirty="0"/>
            </a:br>
            <a:endParaRPr lang="en-IN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78EA8CDA-D9BC-44A5-8979-D2D2E284CA0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962" t="45331" r="5962" b="16497"/>
          <a:stretch/>
        </p:blipFill>
        <p:spPr>
          <a:xfrm>
            <a:off x="112542" y="1825625"/>
            <a:ext cx="11887199" cy="4167212"/>
          </a:xfrm>
          <a:prstGeom prst="rect">
            <a:avLst/>
          </a:prstGeom>
        </p:spPr>
      </p:pic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1423668-43BD-8B7F-B20D-534ADD86C8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976360" y="6356349"/>
            <a:ext cx="2743200" cy="365125"/>
          </a:xfrm>
        </p:spPr>
        <p:txBody>
          <a:bodyPr/>
          <a:lstStyle/>
          <a:p>
            <a:fld id="{C6372C7A-1B5E-454A-A45A-13AF0C11F554}" type="slidenum">
              <a:rPr lang="en-IN" smtClean="0">
                <a:solidFill>
                  <a:srgbClr val="002060"/>
                </a:solidFill>
              </a:rPr>
              <a:t>15</a:t>
            </a:fld>
            <a:endParaRPr lang="en-IN" dirty="0">
              <a:solidFill>
                <a:srgbClr val="002060"/>
              </a:solidFill>
            </a:endParaRPr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E13ACDA-DB5C-F23A-5008-A58B12FCC7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 dirty="0">
                <a:solidFill>
                  <a:srgbClr val="002060"/>
                </a:solidFill>
              </a:rPr>
              <a:t>Apollo Multispeciality Hospital Kolkata, India</a:t>
            </a:r>
            <a:endParaRPr lang="en-IN" dirty="0">
              <a:solidFill>
                <a:srgbClr val="00206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08569592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B6AB21-5A7D-49FD-AC3A-FB1F6D4D60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54745" y="365125"/>
            <a:ext cx="3216811" cy="4671109"/>
          </a:xfrm>
        </p:spPr>
        <p:txBody>
          <a:bodyPr>
            <a:normAutofit fontScale="90000"/>
          </a:bodyPr>
          <a:lstStyle/>
          <a:p>
            <a:r>
              <a:rPr lang="en-IN" dirty="0"/>
              <a:t>FFS-CT beam Placement and dose distribution (3D Representation) – </a:t>
            </a:r>
            <a:r>
              <a:rPr lang="en-IN" b="1" dirty="0">
                <a:solidFill>
                  <a:srgbClr val="00B0F0"/>
                </a:solidFill>
              </a:rPr>
              <a:t>Element -3</a:t>
            </a:r>
          </a:p>
        </p:txBody>
      </p:sp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750FC43D-F46F-4DCD-8457-E25036525A2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3"/>
          <a:srcRect l="1772" t="20440" r="36428" b="11990"/>
          <a:stretch/>
        </p:blipFill>
        <p:spPr>
          <a:xfrm>
            <a:off x="3371556" y="365125"/>
            <a:ext cx="8820444" cy="6359232"/>
          </a:xfrm>
        </p:spPr>
      </p:pic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55330B4-FC1E-71B8-BF87-2FAD30B8E2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72C7A-1B5E-454A-A45A-13AF0C11F554}" type="slidenum">
              <a:rPr lang="en-IN" smtClean="0">
                <a:solidFill>
                  <a:schemeClr val="bg1"/>
                </a:solidFill>
              </a:rPr>
              <a:t>16</a:t>
            </a:fld>
            <a:endParaRPr lang="en-IN" dirty="0">
              <a:solidFill>
                <a:schemeClr val="bg1"/>
              </a:solidFill>
            </a:endParaRPr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9992221-A658-DD29-D410-86848D2BB0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-294250" y="6356350"/>
            <a:ext cx="4114800" cy="365125"/>
          </a:xfrm>
        </p:spPr>
        <p:txBody>
          <a:bodyPr/>
          <a:lstStyle/>
          <a:p>
            <a:r>
              <a:rPr lang="it-IT" dirty="0">
                <a:solidFill>
                  <a:srgbClr val="002060"/>
                </a:solidFill>
              </a:rPr>
              <a:t>Apollo Multispeciality Hospital Kolkata, India</a:t>
            </a:r>
            <a:endParaRPr lang="en-IN" dirty="0">
              <a:solidFill>
                <a:srgbClr val="00206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8572939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B6AB21-5A7D-49FD-AC3A-FB1F6D4D60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280720"/>
            <a:ext cx="10881188" cy="1140118"/>
          </a:xfrm>
        </p:spPr>
        <p:txBody>
          <a:bodyPr>
            <a:normAutofit fontScale="90000"/>
          </a:bodyPr>
          <a:lstStyle/>
          <a:p>
            <a:r>
              <a:rPr lang="en-IN" b="1" u="sng" dirty="0"/>
              <a:t>FFS Plan : </a:t>
            </a:r>
            <a:br>
              <a:rPr lang="en-IN" dirty="0"/>
            </a:br>
            <a:r>
              <a:rPr lang="en-IN" dirty="0"/>
              <a:t>FFS-CT dose distribution (Sagittal and Coronal) 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0F2B903-4502-43E1-A50F-BE70A61C692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IN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64ED27AF-B546-4536-B264-8976B55E15D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6538" t="42048" r="17615" b="24090"/>
          <a:stretch/>
        </p:blipFill>
        <p:spPr>
          <a:xfrm>
            <a:off x="655406" y="1693569"/>
            <a:ext cx="10881188" cy="4883711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FD292658-3E6B-4928-B554-67211F06261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5693" t="30153" r="79115" b="28666"/>
          <a:stretch/>
        </p:blipFill>
        <p:spPr>
          <a:xfrm>
            <a:off x="4594273" y="1746639"/>
            <a:ext cx="2763129" cy="4777569"/>
          </a:xfrm>
          <a:prstGeom prst="rect">
            <a:avLst/>
          </a:prstGeom>
        </p:spPr>
      </p:pic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EC7D563-EAC9-71B4-C6CB-5FA15527E6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9313308" y="6412312"/>
            <a:ext cx="2743200" cy="365125"/>
          </a:xfrm>
        </p:spPr>
        <p:txBody>
          <a:bodyPr/>
          <a:lstStyle/>
          <a:p>
            <a:fld id="{C6372C7A-1B5E-454A-A45A-13AF0C11F554}" type="slidenum">
              <a:rPr lang="en-IN" smtClean="0">
                <a:solidFill>
                  <a:srgbClr val="002060"/>
                </a:solidFill>
              </a:rPr>
              <a:t>17</a:t>
            </a:fld>
            <a:endParaRPr lang="en-IN" dirty="0">
              <a:solidFill>
                <a:srgbClr val="002060"/>
              </a:solidFill>
            </a:endParaRPr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DAB951A-4949-C350-8596-9E3A7205FD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3918437" y="6577278"/>
            <a:ext cx="4114800" cy="365125"/>
          </a:xfrm>
        </p:spPr>
        <p:txBody>
          <a:bodyPr/>
          <a:lstStyle/>
          <a:p>
            <a:r>
              <a:rPr lang="it-IT" dirty="0">
                <a:solidFill>
                  <a:srgbClr val="002060"/>
                </a:solidFill>
              </a:rPr>
              <a:t>Apollo Multispeciality Hospital Kolkata, India</a:t>
            </a:r>
            <a:endParaRPr lang="en-IN" dirty="0">
              <a:solidFill>
                <a:srgbClr val="00206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13826631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1D4931-2FC5-4F84-8D8D-C20DE4AB2F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75251" y="421397"/>
            <a:ext cx="11347936" cy="788426"/>
          </a:xfrm>
        </p:spPr>
        <p:txBody>
          <a:bodyPr>
            <a:normAutofit fontScale="90000"/>
          </a:bodyPr>
          <a:lstStyle/>
          <a:p>
            <a:pPr algn="ctr"/>
            <a:r>
              <a:rPr lang="en-IN" sz="3600" dirty="0"/>
              <a:t>Resultant dose distribution: HFS Plan + FFS Plan+ HFS Junction Plan </a:t>
            </a:r>
            <a:r>
              <a:rPr lang="en-IN" sz="3600" b="1" dirty="0">
                <a:solidFill>
                  <a:srgbClr val="00B0F0"/>
                </a:solidFill>
              </a:rPr>
              <a:t>Element 1+2+3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3C15EB62-556D-416D-8126-2AC4EBAFCCE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654" t="43279" r="24077" b="18139"/>
          <a:stretch/>
        </p:blipFill>
        <p:spPr>
          <a:xfrm>
            <a:off x="365761" y="1690688"/>
            <a:ext cx="9425354" cy="4486276"/>
          </a:xfrm>
          <a:prstGeom prst="rect">
            <a:avLst/>
          </a:prstGeom>
        </p:spPr>
      </p:pic>
      <p:pic>
        <p:nvPicPr>
          <p:cNvPr id="6" name="Content Placeholder 5">
            <a:extLst>
              <a:ext uri="{FF2B5EF4-FFF2-40B4-BE49-F238E27FC236}">
                <a16:creationId xmlns:a16="http://schemas.microsoft.com/office/drawing/2014/main" id="{A74A331A-09BA-40A6-A347-54BD8A059F5A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3"/>
          <a:srcRect l="16118" t="30294" r="79006" b="28524"/>
          <a:stretch/>
        </p:blipFill>
        <p:spPr>
          <a:xfrm>
            <a:off x="9791115" y="1690688"/>
            <a:ext cx="2232072" cy="4486276"/>
          </a:xfrm>
          <a:prstGeom prst="rect">
            <a:avLst/>
          </a:prstGeom>
        </p:spPr>
      </p:pic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F8043A5-9D5D-8953-F966-27D5945AF9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72C7A-1B5E-454A-A45A-13AF0C11F554}" type="slidenum">
              <a:rPr lang="en-IN" smtClean="0">
                <a:solidFill>
                  <a:srgbClr val="002060"/>
                </a:solidFill>
              </a:rPr>
              <a:t>18</a:t>
            </a:fld>
            <a:endParaRPr lang="en-IN" dirty="0">
              <a:solidFill>
                <a:srgbClr val="002060"/>
              </a:solidFill>
            </a:endParaRPr>
          </a:p>
        </p:txBody>
      </p:sp>
      <p:sp>
        <p:nvSpPr>
          <p:cNvPr id="7" name="Footer Placeholder 6">
            <a:extLst>
              <a:ext uri="{FF2B5EF4-FFF2-40B4-BE49-F238E27FC236}">
                <a16:creationId xmlns:a16="http://schemas.microsoft.com/office/drawing/2014/main" id="{BBCCD5BE-B5E4-89AB-6B30-8F0B468808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 dirty="0">
                <a:solidFill>
                  <a:srgbClr val="002060"/>
                </a:solidFill>
              </a:rPr>
              <a:t>Apollo Multispeciality Hospital Kolkata, India</a:t>
            </a:r>
            <a:endParaRPr lang="en-IN" dirty="0">
              <a:solidFill>
                <a:srgbClr val="00206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19571664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73F954-99AA-F5D7-3147-ECB04ADF68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95996" y="138554"/>
            <a:ext cx="9248335" cy="762319"/>
          </a:xfrm>
        </p:spPr>
        <p:txBody>
          <a:bodyPr>
            <a:normAutofit fontScale="90000"/>
          </a:bodyPr>
          <a:lstStyle/>
          <a:p>
            <a:r>
              <a:rPr lang="en-IN" dirty="0"/>
              <a:t>Typical Dose Distribution (lung :superior) </a:t>
            </a:r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414CAC9-0B93-B4E5-554E-9CBE7D421C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pollo Multispeciality Hospital Kolkata, India</a:t>
            </a:r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4AEFE3F-0B76-794A-8DBF-E710164195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72C7A-1B5E-454A-A45A-13AF0C11F554}" type="slidenum">
              <a:rPr lang="en-IN" smtClean="0"/>
              <a:t>19</a:t>
            </a:fld>
            <a:endParaRPr lang="en-IN"/>
          </a:p>
        </p:txBody>
      </p:sp>
      <p:pic>
        <p:nvPicPr>
          <p:cNvPr id="8" name="Content Placeholder 6">
            <a:extLst>
              <a:ext uri="{FF2B5EF4-FFF2-40B4-BE49-F238E27FC236}">
                <a16:creationId xmlns:a16="http://schemas.microsoft.com/office/drawing/2014/main" id="{15F8A512-B240-3202-52B7-61F27F0F114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7430" b="52185"/>
          <a:stretch/>
        </p:blipFill>
        <p:spPr>
          <a:xfrm>
            <a:off x="1063283" y="900873"/>
            <a:ext cx="9557825" cy="52731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764081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EAE9F1-F2D4-48D3-B9E4-8E3C268560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IN" dirty="0"/>
              <a:t>Simulation: Lean patient</a:t>
            </a:r>
          </a:p>
        </p:txBody>
      </p:sp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7BDAAD70-006B-4AFF-8023-DB730F5DE8EE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9711" y="1825625"/>
            <a:ext cx="9432577" cy="4351338"/>
          </a:xfrm>
        </p:spPr>
      </p:pic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713C917-67D8-AAFB-7708-80213C9F10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72C7A-1B5E-454A-A45A-13AF0C11F554}" type="slidenum">
              <a:rPr lang="en-IN" smtClean="0">
                <a:solidFill>
                  <a:srgbClr val="002060"/>
                </a:solidFill>
              </a:rPr>
              <a:t>2</a:t>
            </a:fld>
            <a:endParaRPr lang="en-IN" dirty="0">
              <a:solidFill>
                <a:srgbClr val="002060"/>
              </a:solidFill>
            </a:endParaRPr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58CB0E2-7343-1C1C-6DE4-22B6C27AB9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 dirty="0">
                <a:solidFill>
                  <a:srgbClr val="002060"/>
                </a:solidFill>
              </a:rPr>
              <a:t>Apollo Multispeciality Hospital Kolkata, India</a:t>
            </a:r>
            <a:endParaRPr lang="en-IN" dirty="0">
              <a:solidFill>
                <a:srgbClr val="00206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5101430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73F954-99AA-F5D7-3147-ECB04ADF68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95996" y="138554"/>
            <a:ext cx="9248335" cy="762319"/>
          </a:xfrm>
        </p:spPr>
        <p:txBody>
          <a:bodyPr>
            <a:normAutofit fontScale="90000"/>
          </a:bodyPr>
          <a:lstStyle/>
          <a:p>
            <a:r>
              <a:rPr lang="en-IN" dirty="0"/>
              <a:t>Typical Dose Distribution (lung: mid level) </a:t>
            </a:r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414CAC9-0B93-B4E5-554E-9CBE7D421C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pollo Multispeciality Hospital Kolkata, India</a:t>
            </a:r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4AEFE3F-0B76-794A-8DBF-E710164195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72C7A-1B5E-454A-A45A-13AF0C11F554}" type="slidenum">
              <a:rPr lang="en-IN" smtClean="0"/>
              <a:t>20</a:t>
            </a:fld>
            <a:endParaRPr lang="en-IN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B2E474E6-F330-D602-6F3B-5F2F985A35F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8231" b="62997"/>
          <a:stretch/>
        </p:blipFill>
        <p:spPr>
          <a:xfrm>
            <a:off x="1172394" y="808791"/>
            <a:ext cx="9622127" cy="55475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33907584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73F954-99AA-F5D7-3147-ECB04ADF68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95996" y="138554"/>
            <a:ext cx="9248335" cy="762319"/>
          </a:xfrm>
        </p:spPr>
        <p:txBody>
          <a:bodyPr>
            <a:normAutofit/>
          </a:bodyPr>
          <a:lstStyle/>
          <a:p>
            <a:r>
              <a:rPr lang="en-IN" dirty="0"/>
              <a:t>Typical Dose Distribution (Kidney level)</a:t>
            </a:r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414CAC9-0B93-B4E5-554E-9CBE7D421C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/>
              <a:t>Apollo Multispeciality Hospital Kolkata, India</a:t>
            </a:r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4AEFE3F-0B76-794A-8DBF-E710164195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72C7A-1B5E-454A-A45A-13AF0C11F554}" type="slidenum">
              <a:rPr lang="en-IN" smtClean="0"/>
              <a:t>21</a:t>
            </a:fld>
            <a:endParaRPr lang="en-IN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479E6217-5EF6-A9CE-9B7C-CDA38961070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22" r="59500" b="65549"/>
          <a:stretch/>
        </p:blipFill>
        <p:spPr>
          <a:xfrm>
            <a:off x="795996" y="900872"/>
            <a:ext cx="10600008" cy="54554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043920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B17829-FC6A-4D23-BF2A-3A56B87A12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8372" y="702749"/>
            <a:ext cx="2903806" cy="5641780"/>
          </a:xfrm>
        </p:spPr>
        <p:txBody>
          <a:bodyPr>
            <a:normAutofit fontScale="90000"/>
          </a:bodyPr>
          <a:lstStyle/>
          <a:p>
            <a:r>
              <a:rPr lang="en-IN" b="1" u="sng" dirty="0"/>
              <a:t>Junction Plan </a:t>
            </a:r>
            <a:r>
              <a:rPr lang="en-IN" dirty="0"/>
              <a:t>Junction Contour, and AP-PA open Beam Plan in HFS CT Set ,</a:t>
            </a:r>
            <a:br>
              <a:rPr lang="en-IN" dirty="0"/>
            </a:br>
            <a:r>
              <a:rPr lang="en-IN" b="1" dirty="0">
                <a:solidFill>
                  <a:srgbClr val="00B0F0"/>
                </a:solidFill>
              </a:rPr>
              <a:t>Element-1</a:t>
            </a:r>
            <a:br>
              <a:rPr lang="en-IN" dirty="0"/>
            </a:br>
            <a:endParaRPr lang="en-IN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3B820662-8AFD-438D-B1F0-F5D1E07182F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2709" b="10894"/>
          <a:stretch/>
        </p:blipFill>
        <p:spPr>
          <a:xfrm>
            <a:off x="3483064" y="123574"/>
            <a:ext cx="8567085" cy="6460106"/>
          </a:xfrm>
          <a:prstGeom prst="rect">
            <a:avLst/>
          </a:prstGeom>
        </p:spPr>
      </p:pic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9EEFA71-83FC-771A-537E-824B484D95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141850" y="187667"/>
            <a:ext cx="316521" cy="365125"/>
          </a:xfrm>
        </p:spPr>
        <p:txBody>
          <a:bodyPr/>
          <a:lstStyle/>
          <a:p>
            <a:fld id="{C6372C7A-1B5E-454A-A45A-13AF0C11F554}" type="slidenum">
              <a:rPr lang="en-IN" smtClean="0">
                <a:solidFill>
                  <a:srgbClr val="002060"/>
                </a:solidFill>
              </a:rPr>
              <a:t>3</a:t>
            </a:fld>
            <a:endParaRPr lang="en-IN">
              <a:solidFill>
                <a:srgbClr val="002060"/>
              </a:solidFill>
            </a:endParaRPr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E42DBE-C294-1C65-01D0-316AF3CB82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-125368" y="6397435"/>
            <a:ext cx="4114800" cy="365125"/>
          </a:xfrm>
        </p:spPr>
        <p:txBody>
          <a:bodyPr/>
          <a:lstStyle/>
          <a:p>
            <a:r>
              <a:rPr lang="it-IT" dirty="0">
                <a:solidFill>
                  <a:srgbClr val="002060"/>
                </a:solidFill>
              </a:rPr>
              <a:t>Apollo Multispeciality Hospital Kolkata, India</a:t>
            </a:r>
            <a:endParaRPr lang="en-IN" dirty="0">
              <a:solidFill>
                <a:srgbClr val="00206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2414972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C1FE35-AA05-4A1A-AE12-3719D32F94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0166" y="365125"/>
            <a:ext cx="11619914" cy="1325563"/>
          </a:xfrm>
        </p:spPr>
        <p:txBody>
          <a:bodyPr/>
          <a:lstStyle/>
          <a:p>
            <a:r>
              <a:rPr lang="en-IN" dirty="0"/>
              <a:t>Beam Arrangement for Junction Contour and MU 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16D4BFAB-A06B-48B1-AFE0-AA289B263E6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192" t="59903" r="5500" b="24910"/>
          <a:stretch/>
        </p:blipFill>
        <p:spPr>
          <a:xfrm>
            <a:off x="154745" y="2387990"/>
            <a:ext cx="11774658" cy="2296552"/>
          </a:xfrm>
          <a:prstGeom prst="rect">
            <a:avLst/>
          </a:prstGeom>
        </p:spPr>
      </p:pic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1A8D793-33C1-A987-EC01-6C1BCAC0C1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72C7A-1B5E-454A-A45A-13AF0C11F554}" type="slidenum">
              <a:rPr lang="en-IN" smtClean="0">
                <a:solidFill>
                  <a:srgbClr val="002060"/>
                </a:solidFill>
              </a:rPr>
              <a:t>4</a:t>
            </a:fld>
            <a:endParaRPr lang="en-IN" dirty="0">
              <a:solidFill>
                <a:srgbClr val="002060"/>
              </a:solidFill>
            </a:endParaRPr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DA537E-8FD5-3A57-0B50-342F7389C7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 dirty="0">
                <a:solidFill>
                  <a:srgbClr val="002060"/>
                </a:solidFill>
              </a:rPr>
              <a:t>Apollo Multispeciality Hospital Kolkata, India</a:t>
            </a:r>
            <a:endParaRPr lang="en-IN" dirty="0">
              <a:solidFill>
                <a:srgbClr val="00206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891392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D4E580-5922-4265-9B8E-9F30FE4CCA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62598" y="755979"/>
            <a:ext cx="3943644" cy="5163478"/>
          </a:xfrm>
        </p:spPr>
        <p:txBody>
          <a:bodyPr>
            <a:normAutofit fontScale="90000"/>
          </a:bodyPr>
          <a:lstStyle/>
          <a:p>
            <a:r>
              <a:rPr lang="en-IN" b="1" u="sng" dirty="0"/>
              <a:t>HFS Plan </a:t>
            </a:r>
            <a:br>
              <a:rPr lang="en-IN" dirty="0"/>
            </a:br>
            <a:br>
              <a:rPr lang="en-IN" dirty="0"/>
            </a:br>
            <a:r>
              <a:rPr lang="en-IN" dirty="0"/>
              <a:t>Creation of  PTV segments for ease of optimization and better control over dose build-up during optimization over each PTV segment.</a:t>
            </a:r>
          </a:p>
        </p:txBody>
      </p:sp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E560F3C7-FF89-49FD-9993-5814F916EB2A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06241" y="0"/>
            <a:ext cx="7723162" cy="6675437"/>
          </a:xfrm>
        </p:spPr>
      </p:pic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C9A5E88-8216-9E71-77E1-C992C7DD68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9448800" y="6472090"/>
            <a:ext cx="2743200" cy="365125"/>
          </a:xfrm>
        </p:spPr>
        <p:txBody>
          <a:bodyPr/>
          <a:lstStyle/>
          <a:p>
            <a:fld id="{C6372C7A-1B5E-454A-A45A-13AF0C11F554}" type="slidenum">
              <a:rPr lang="en-IN" smtClean="0">
                <a:solidFill>
                  <a:srgbClr val="002060"/>
                </a:solidFill>
              </a:rPr>
              <a:t>5</a:t>
            </a:fld>
            <a:endParaRPr lang="en-IN" dirty="0">
              <a:solidFill>
                <a:srgbClr val="002060"/>
              </a:solidFill>
            </a:endParaRPr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9DDAEAC-03EE-8E3F-06FC-09D479247B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0" y="6492873"/>
            <a:ext cx="4114800" cy="365125"/>
          </a:xfrm>
        </p:spPr>
        <p:txBody>
          <a:bodyPr/>
          <a:lstStyle/>
          <a:p>
            <a:r>
              <a:rPr lang="it-IT" dirty="0">
                <a:solidFill>
                  <a:srgbClr val="002060"/>
                </a:solidFill>
              </a:rPr>
              <a:t>Apollo Multispeciality Hospital Kolkata, India</a:t>
            </a:r>
            <a:endParaRPr lang="en-IN" dirty="0">
              <a:solidFill>
                <a:srgbClr val="00206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2247355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E70851-FFD5-48A0-936A-F549D15E83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39726" y="111908"/>
            <a:ext cx="10515600" cy="675884"/>
          </a:xfrm>
        </p:spPr>
        <p:txBody>
          <a:bodyPr>
            <a:normAutofit fontScale="90000"/>
          </a:bodyPr>
          <a:lstStyle/>
          <a:p>
            <a:r>
              <a:rPr lang="en-IN" dirty="0"/>
              <a:t>Beam Arrangement and MU _HFS 1 of 2 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B58043EE-E575-46B3-83DF-ADAA349402B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55" t="36097" r="4577" b="19164"/>
          <a:stretch/>
        </p:blipFill>
        <p:spPr>
          <a:xfrm>
            <a:off x="0" y="1426625"/>
            <a:ext cx="12192000" cy="4664686"/>
          </a:xfrm>
          <a:prstGeom prst="rect">
            <a:avLst/>
          </a:prstGeom>
        </p:spPr>
      </p:pic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17ACD1B-9AB0-4D7D-7DB1-041D3526C5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72C7A-1B5E-454A-A45A-13AF0C11F554}" type="slidenum">
              <a:rPr lang="en-IN" smtClean="0">
                <a:solidFill>
                  <a:srgbClr val="002060"/>
                </a:solidFill>
              </a:rPr>
              <a:t>6</a:t>
            </a:fld>
            <a:endParaRPr lang="en-IN" dirty="0">
              <a:solidFill>
                <a:srgbClr val="002060"/>
              </a:solidFill>
            </a:endParaRPr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335316C-EE88-CA0A-D7C2-2DD08BFCEB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 dirty="0">
                <a:solidFill>
                  <a:srgbClr val="002060"/>
                </a:solidFill>
              </a:rPr>
              <a:t>Apollo Multispeciality Hospital Kolkata, India</a:t>
            </a:r>
            <a:endParaRPr lang="en-IN" dirty="0">
              <a:solidFill>
                <a:srgbClr val="002060"/>
              </a:solidFill>
            </a:endParaRPr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C4978947-136F-1E1B-F363-0DAFF5A03B97}"/>
              </a:ext>
            </a:extLst>
          </p:cNvPr>
          <p:cNvCxnSpPr/>
          <p:nvPr/>
        </p:nvCxnSpPr>
        <p:spPr>
          <a:xfrm>
            <a:off x="0" y="3443068"/>
            <a:ext cx="1178872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2487579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E70851-FFD5-48A0-936A-F549D15E83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39726" y="111908"/>
            <a:ext cx="10515600" cy="675884"/>
          </a:xfrm>
        </p:spPr>
        <p:txBody>
          <a:bodyPr>
            <a:normAutofit fontScale="90000"/>
          </a:bodyPr>
          <a:lstStyle/>
          <a:p>
            <a:r>
              <a:rPr lang="en-IN" dirty="0"/>
              <a:t>Beam Arrangement and MU _HFS 2 of 2 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A314CECB-14E1-468F-848D-9D027BC1996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386" t="15164" r="6067" b="32709"/>
          <a:stretch/>
        </p:blipFill>
        <p:spPr>
          <a:xfrm>
            <a:off x="168812" y="787792"/>
            <a:ext cx="11901268" cy="5584873"/>
          </a:xfrm>
          <a:prstGeom prst="rect">
            <a:avLst/>
          </a:prstGeom>
        </p:spPr>
      </p:pic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2C4F04A-39F2-4EEE-385D-0DB5F90644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72C7A-1B5E-454A-A45A-13AF0C11F554}" type="slidenum">
              <a:rPr lang="en-IN" smtClean="0">
                <a:solidFill>
                  <a:srgbClr val="002060"/>
                </a:solidFill>
              </a:rPr>
              <a:t>7</a:t>
            </a:fld>
            <a:endParaRPr lang="en-IN" dirty="0">
              <a:solidFill>
                <a:srgbClr val="002060"/>
              </a:solidFill>
            </a:endParaRPr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A47C2E-7110-55C0-A1AD-99C3ECF6A6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it-IT" dirty="0">
                <a:solidFill>
                  <a:srgbClr val="002060"/>
                </a:solidFill>
              </a:rPr>
              <a:t>Apollo Multispeciality Hospital Kolkata, India</a:t>
            </a:r>
            <a:endParaRPr lang="en-IN" dirty="0">
              <a:solidFill>
                <a:srgbClr val="00206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224911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B17829-FC6A-4D23-BF2A-3A56B87A12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1026942"/>
            <a:ext cx="3108960" cy="2630659"/>
          </a:xfrm>
        </p:spPr>
        <p:txBody>
          <a:bodyPr>
            <a:normAutofit fontScale="90000"/>
          </a:bodyPr>
          <a:lstStyle/>
          <a:p>
            <a:r>
              <a:rPr lang="en-IN" b="1" u="sng" dirty="0"/>
              <a:t>HFS</a:t>
            </a:r>
            <a:br>
              <a:rPr lang="en-IN" dirty="0"/>
            </a:br>
            <a:br>
              <a:rPr lang="en-IN" dirty="0"/>
            </a:br>
            <a:r>
              <a:rPr lang="en-IN" dirty="0"/>
              <a:t>Optimization Parameters Set -1 of 4 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1930900-05BE-4B5D-5BD4-57429A00F6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9448800" y="6356349"/>
            <a:ext cx="2743200" cy="365125"/>
          </a:xfrm>
        </p:spPr>
        <p:txBody>
          <a:bodyPr/>
          <a:lstStyle/>
          <a:p>
            <a:fld id="{C6372C7A-1B5E-454A-A45A-13AF0C11F554}" type="slidenum">
              <a:rPr lang="en-IN" smtClean="0">
                <a:solidFill>
                  <a:srgbClr val="002060"/>
                </a:solidFill>
              </a:rPr>
              <a:t>8</a:t>
            </a:fld>
            <a:endParaRPr lang="en-IN" dirty="0">
              <a:solidFill>
                <a:srgbClr val="002060"/>
              </a:solidFill>
            </a:endParaRPr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47655CA-ABEA-BD1D-1418-002364E482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3590778" y="6356349"/>
            <a:ext cx="4114800" cy="365125"/>
          </a:xfrm>
        </p:spPr>
        <p:txBody>
          <a:bodyPr/>
          <a:lstStyle/>
          <a:p>
            <a:r>
              <a:rPr lang="it-IT" dirty="0">
                <a:solidFill>
                  <a:srgbClr val="002060"/>
                </a:solidFill>
              </a:rPr>
              <a:t>Apollo Multispeciality Hospital Kolkata, India</a:t>
            </a:r>
            <a:endParaRPr lang="en-IN" dirty="0">
              <a:solidFill>
                <a:srgbClr val="002060"/>
              </a:solidFill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/>
          <a:srcRect t="2158" b="4755"/>
          <a:stretch/>
        </p:blipFill>
        <p:spPr>
          <a:xfrm>
            <a:off x="3178206" y="139337"/>
            <a:ext cx="8857040" cy="62170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8745286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B17829-FC6A-4D23-BF2A-3A56B87A12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2362737"/>
            <a:ext cx="3108960" cy="1927909"/>
          </a:xfrm>
        </p:spPr>
        <p:txBody>
          <a:bodyPr>
            <a:normAutofit fontScale="90000"/>
          </a:bodyPr>
          <a:lstStyle/>
          <a:p>
            <a:r>
              <a:rPr lang="en-IN" b="1" u="sng" dirty="0"/>
              <a:t>HFS</a:t>
            </a:r>
            <a:br>
              <a:rPr lang="en-IN" dirty="0"/>
            </a:br>
            <a:br>
              <a:rPr lang="en-IN" dirty="0"/>
            </a:br>
            <a:r>
              <a:rPr lang="en-IN" dirty="0"/>
              <a:t>Optimization Parameters Set -2 of 4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5269333-E297-D930-C5B3-159F55308C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9215511" y="6408151"/>
            <a:ext cx="2743200" cy="365125"/>
          </a:xfrm>
        </p:spPr>
        <p:txBody>
          <a:bodyPr/>
          <a:lstStyle/>
          <a:p>
            <a:fld id="{C6372C7A-1B5E-454A-A45A-13AF0C11F554}" type="slidenum">
              <a:rPr lang="en-IN" smtClean="0">
                <a:solidFill>
                  <a:srgbClr val="002060"/>
                </a:solidFill>
              </a:rPr>
              <a:t>9</a:t>
            </a:fld>
            <a:endParaRPr lang="en-IN">
              <a:solidFill>
                <a:srgbClr val="002060"/>
              </a:solidFill>
            </a:endParaRPr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F4C5F8B-A09A-4264-3895-D569FE72B4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492875"/>
            <a:ext cx="4114800" cy="365125"/>
          </a:xfrm>
        </p:spPr>
        <p:txBody>
          <a:bodyPr/>
          <a:lstStyle/>
          <a:p>
            <a:r>
              <a:rPr lang="it-IT">
                <a:solidFill>
                  <a:srgbClr val="002060"/>
                </a:solidFill>
              </a:rPr>
              <a:t>Apollo Multispeciality Hospital Kolkata, India</a:t>
            </a:r>
            <a:endParaRPr lang="en-IN">
              <a:solidFill>
                <a:srgbClr val="002060"/>
              </a:solidFill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/>
          <a:srcRect t="3132" b="4251"/>
          <a:stretch/>
        </p:blipFill>
        <p:spPr>
          <a:xfrm>
            <a:off x="3108960" y="200297"/>
            <a:ext cx="9056914" cy="62078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710862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2</TotalTime>
  <Words>398</Words>
  <Application>Microsoft Office PowerPoint</Application>
  <PresentationFormat>Widescreen</PresentationFormat>
  <Paragraphs>68</Paragraphs>
  <Slides>21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1</vt:i4>
      </vt:variant>
    </vt:vector>
  </HeadingPairs>
  <TitlesOfParts>
    <vt:vector size="25" baseType="lpstr">
      <vt:lpstr>Arial</vt:lpstr>
      <vt:lpstr>Calibri</vt:lpstr>
      <vt:lpstr>Calibri Light</vt:lpstr>
      <vt:lpstr>Office Theme</vt:lpstr>
      <vt:lpstr>TMI/TMLI Patient Simulation and planning Detail</vt:lpstr>
      <vt:lpstr>Simulation: Lean patient</vt:lpstr>
      <vt:lpstr>Junction Plan Junction Contour, and AP-PA open Beam Plan in HFS CT Set , Element-1 </vt:lpstr>
      <vt:lpstr>Beam Arrangement for Junction Contour and MU </vt:lpstr>
      <vt:lpstr>HFS Plan   Creation of  PTV segments for ease of optimization and better control over dose build-up during optimization over each PTV segment.</vt:lpstr>
      <vt:lpstr>Beam Arrangement and MU _HFS 1 of 2 </vt:lpstr>
      <vt:lpstr>Beam Arrangement and MU _HFS 2 of 2 </vt:lpstr>
      <vt:lpstr>HFS  Optimization Parameters Set -1 of 4 </vt:lpstr>
      <vt:lpstr>HFS  Optimization Parameters Set -2 of 4</vt:lpstr>
      <vt:lpstr>HFS  Optimization Parameters Set -3 of 4</vt:lpstr>
      <vt:lpstr>HFS   Optimization Parameters Set -4 of 4</vt:lpstr>
      <vt:lpstr>Isocentre placement and Dose Distribution (coronal)-HFS  Element-2</vt:lpstr>
      <vt:lpstr>Isocentre placement and Dose Distribution (Sagittal)-HFS</vt:lpstr>
      <vt:lpstr>Arcs and Dose Distribution (Axial)- HFS CT</vt:lpstr>
      <vt:lpstr>FFS Plan :  Beam Arrangement and MU </vt:lpstr>
      <vt:lpstr>FFS-CT beam Placement and dose distribution (3D Representation) – Element -3</vt:lpstr>
      <vt:lpstr>FFS Plan :  FFS-CT dose distribution (Sagittal and Coronal) </vt:lpstr>
      <vt:lpstr>Resultant dose distribution: HFS Plan + FFS Plan+ HFS Junction Plan Element 1+2+3</vt:lpstr>
      <vt:lpstr>Typical Dose Distribution (lung :superior) </vt:lpstr>
      <vt:lpstr>Typical Dose Distribution (lung: mid level) </vt:lpstr>
      <vt:lpstr>Typical Dose Distribution (Kidney level)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iplab Sarkar</dc:creator>
  <cp:lastModifiedBy>Biplab Sarkar</cp:lastModifiedBy>
  <cp:revision>43</cp:revision>
  <dcterms:created xsi:type="dcterms:W3CDTF">2022-03-10T17:24:08Z</dcterms:created>
  <dcterms:modified xsi:type="dcterms:W3CDTF">2022-08-09T07:12:19Z</dcterms:modified>
</cp:coreProperties>
</file>